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1" r:id="rId4"/>
    <p:sldId id="258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5" autoAdjust="0"/>
    <p:restoredTop sz="94268" autoAdjust="0"/>
  </p:normalViewPr>
  <p:slideViewPr>
    <p:cSldViewPr snapToGrid="0">
      <p:cViewPr varScale="1">
        <p:scale>
          <a:sx n="108" d="100"/>
          <a:sy n="108" d="100"/>
        </p:scale>
        <p:origin x="14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60B5C-539D-616A-2488-DDF79247DB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44E926-6B88-7298-F04A-FB0C28D686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11A1EA-BB11-A631-D041-E4FFE5621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3A9951-6004-2BF9-FEEB-605AEA587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DC9F72-FCCB-508F-5115-AB7118B35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408480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5048E-7CE4-129A-3D86-506F586ADB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A20CC-D68A-3ADE-AE5B-AAB5CF602D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956AB1-364B-8AFA-E231-912292ABD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6E8BF0-6108-B7A6-FE6A-B949D99C56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66601-A34B-14F9-0911-41F31F2CD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68267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198CC9-DA16-799C-CADE-5E825649C4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BAB6FF-A3AC-5EC4-BA76-3BF7D22D04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C2FB48-CE66-6EDB-87C0-E771C3155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B988A6-E8C6-C50B-9A02-3715F415D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09B6A6-E24F-2593-B23B-CBDFE5B2B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431225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D97C68-F66A-3E57-59C0-C9E9615FED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47727B-4265-7AAA-3C9D-84F6D91579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2D5111-170A-BF49-A847-274009BB5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BFD5E6-8E21-7E79-2151-0B1A8A74C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96C104-868C-09C5-6116-99FCB7407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1587923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59FEBA-19D3-B08C-455F-73759AD521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65C6AC-BD32-0EC9-1A74-7E74D23E9F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FC9C6B-6E3D-BEEB-5EFA-7C9885854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304F22-C72F-B82E-5851-8BC195592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361031-38DF-A897-D533-D207996A3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714494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13731-38EB-24DD-21DD-D6D015845E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94A115-F440-D3E2-B1CD-7A95F6628B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5D968F-43E9-A3E3-79B4-D2D887A50C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0FA89B-96E2-23C1-8F12-5173D71D8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F81ED4-38E9-3A0A-5137-23F18DCDC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927F57-26B7-AB2E-E36D-56180A016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52920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1ECB3-0C40-0350-E720-3909A4A4F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590797-3D3D-B5D6-9FB7-405FEAD559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034B09-4122-56C5-05E6-E78885F6C5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7F5947-01B1-5702-5830-A4002B09FF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3FE6EC-71F8-B82F-88F9-2AB5EDB880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3302EE-80CC-6172-2CE6-FB2495362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09B12A-C1DD-D8D9-251C-648BE9AC9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967CAB-1E32-FC69-9F9F-ECCB37AAE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962186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EECFB-E758-7C3F-14CF-B5D8C6B34A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0CDAC6-B1A2-7A8E-CA0E-1DE689978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3E2C1F-049E-8093-2CBB-874D03AC3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853BC3-A0CC-5B3C-1127-55D3FCE7D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212319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B8E894-E6AE-D69F-C6A3-737052F95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2F55FC-00AF-D165-8044-0553D0A3F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CA6E93-F139-915D-2305-6704C822F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609464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A49824-3AA4-F58B-BF1A-0158E7A9D8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E02A7A-484C-481E-4A42-0CAC07AFFB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7BEDF4-4F86-5E90-EA54-0A5C1EC032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DC9F09-E477-AFB0-0C94-D4D548B13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4D7456-B54C-2C5A-288E-72166AF58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DC838D-AC84-D095-1B52-F5ADE523A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981328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CFD9A-D65F-0028-F98B-60D3C8624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22731F-AA81-C930-A9EF-C3F3B20A72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H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913C7B-6391-E8C8-7408-04C5B53464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C96A20-E5F6-D274-59BF-0E1428CB1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69BB3-6E1D-634D-3793-635A8A1A8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4B5A84-3A75-BE99-411D-7CDF5D600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627799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4E7EC9-0029-0DA5-FA6D-3C4A58F44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H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3808BE-0ACD-7B2D-8019-E7238E4FD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7C3D14-5E4F-CEA9-EDE3-CE0B5D519A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EA4E1B-EA00-4BFF-ACAD-530AD440A4B0}" type="datetimeFigureOut">
              <a:rPr lang="en-HK" smtClean="0"/>
              <a:t>5/12/2024</a:t>
            </a:fld>
            <a:endParaRPr lang="en-H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F73D9-DC17-0687-321E-CB377C35AD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H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BB60FD-FA0F-3648-6FF4-3CEB779A39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FEBB06-5C92-4406-878B-93CADBFD2CCB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1071060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jpe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2E360-2D76-7DD6-885B-B7EEED851B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HK"/>
              <a:t>Figure 2D</a:t>
            </a:r>
            <a:endParaRPr lang="en-HK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F08792-9F91-DE1C-9D68-B950DC550B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02315" y="1598966"/>
            <a:ext cx="3146638" cy="4351338"/>
          </a:xfrm>
        </p:spPr>
        <p:txBody>
          <a:bodyPr>
            <a:normAutofit/>
          </a:bodyPr>
          <a:lstStyle/>
          <a:p>
            <a:pPr marL="0" indent="0" algn="r">
              <a:lnSpc>
                <a:spcPct val="220000"/>
              </a:lnSpc>
              <a:buNone/>
            </a:pPr>
            <a:r>
              <a:rPr lang="en-HK" sz="2400" dirty="0"/>
              <a:t>p-Akt(Ser473)</a:t>
            </a:r>
          </a:p>
          <a:p>
            <a:pPr marL="0" indent="0" algn="r">
              <a:lnSpc>
                <a:spcPct val="220000"/>
              </a:lnSpc>
              <a:buNone/>
            </a:pPr>
            <a:r>
              <a:rPr lang="en-HK" sz="2400" dirty="0"/>
              <a:t>t-Akt </a:t>
            </a:r>
          </a:p>
          <a:p>
            <a:pPr marL="0" indent="0" algn="r">
              <a:lnSpc>
                <a:spcPct val="220000"/>
              </a:lnSpc>
              <a:buNone/>
            </a:pPr>
            <a:r>
              <a:rPr lang="en-HK" sz="2400" dirty="0"/>
              <a:t>p-S6 (Ser235/236)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00586E3-3F9A-626C-64AF-E404C8989B23}"/>
              </a:ext>
            </a:extLst>
          </p:cNvPr>
          <p:cNvSpPr txBox="1"/>
          <p:nvPr/>
        </p:nvSpPr>
        <p:spPr>
          <a:xfrm rot="16200000">
            <a:off x="9576866" y="285844"/>
            <a:ext cx="849913" cy="25869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HK" dirty="0"/>
              <a:t>EGFP</a:t>
            </a:r>
          </a:p>
          <a:p>
            <a:pPr>
              <a:lnSpc>
                <a:spcPct val="130000"/>
              </a:lnSpc>
            </a:pPr>
            <a:r>
              <a:rPr lang="en-HK" dirty="0"/>
              <a:t>WT</a:t>
            </a:r>
          </a:p>
          <a:p>
            <a:pPr>
              <a:lnSpc>
                <a:spcPct val="130000"/>
              </a:lnSpc>
            </a:pPr>
            <a:r>
              <a:rPr lang="en-HK" dirty="0"/>
              <a:t>P29S</a:t>
            </a:r>
          </a:p>
          <a:p>
            <a:pPr>
              <a:lnSpc>
                <a:spcPct val="130000"/>
              </a:lnSpc>
            </a:pPr>
            <a:r>
              <a:rPr lang="en-HK" dirty="0"/>
              <a:t>K116N</a:t>
            </a:r>
          </a:p>
          <a:p>
            <a:pPr>
              <a:lnSpc>
                <a:spcPct val="130000"/>
              </a:lnSpc>
            </a:pPr>
            <a:r>
              <a:rPr lang="en-HK" dirty="0"/>
              <a:t>A159V</a:t>
            </a:r>
          </a:p>
          <a:p>
            <a:pPr>
              <a:lnSpc>
                <a:spcPct val="130000"/>
              </a:lnSpc>
            </a:pPr>
            <a:r>
              <a:rPr lang="en-HK" dirty="0"/>
              <a:t>G15S</a:t>
            </a:r>
          </a:p>
          <a:p>
            <a:pPr>
              <a:lnSpc>
                <a:spcPct val="130000"/>
              </a:lnSpc>
            </a:pPr>
            <a:r>
              <a:rPr lang="en-HK" dirty="0"/>
              <a:t>N39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BE4CD45-22E3-9661-DBD2-68155B90F39B}"/>
              </a:ext>
            </a:extLst>
          </p:cNvPr>
          <p:cNvSpPr txBox="1"/>
          <p:nvPr/>
        </p:nvSpPr>
        <p:spPr>
          <a:xfrm>
            <a:off x="8513811" y="941031"/>
            <a:ext cx="3031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u="sng" dirty="0"/>
              <a:t>       PECAPJ41CLONED2          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1E8AD0-AE9E-0801-B713-46F526B432D8}"/>
              </a:ext>
            </a:extLst>
          </p:cNvPr>
          <p:cNvSpPr txBox="1"/>
          <p:nvPr/>
        </p:nvSpPr>
        <p:spPr>
          <a:xfrm>
            <a:off x="5566081" y="627455"/>
            <a:ext cx="2947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b="1" dirty="0">
                <a:solidFill>
                  <a:srgbClr val="FF0000"/>
                </a:solidFill>
              </a:rPr>
              <a:t>Original western blot films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094C1BF-722A-AAA0-2097-FAFB910A1C4B}"/>
              </a:ext>
            </a:extLst>
          </p:cNvPr>
          <p:cNvCxnSpPr/>
          <p:nvPr/>
        </p:nvCxnSpPr>
        <p:spPr>
          <a:xfrm>
            <a:off x="5133120" y="23671"/>
            <a:ext cx="69195" cy="683432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CBCC8CA7-B84E-8A09-F5F7-EAAC21E0DB9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2592"/>
          <a:stretch/>
        </p:blipFill>
        <p:spPr>
          <a:xfrm>
            <a:off x="36460" y="1776412"/>
            <a:ext cx="5131257" cy="310958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876D01F-F4BE-9E65-14A1-F8A2BD97A48A}"/>
              </a:ext>
            </a:extLst>
          </p:cNvPr>
          <p:cNvSpPr txBox="1"/>
          <p:nvPr/>
        </p:nvSpPr>
        <p:spPr>
          <a:xfrm>
            <a:off x="2346755" y="4350827"/>
            <a:ext cx="6094206" cy="15994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lnSpc>
                <a:spcPct val="220000"/>
              </a:lnSpc>
              <a:buNone/>
            </a:pPr>
            <a:r>
              <a:rPr lang="en-HK" sz="2400" dirty="0"/>
              <a:t>t-S6</a:t>
            </a:r>
          </a:p>
          <a:p>
            <a:pPr marL="0" indent="0" algn="r">
              <a:lnSpc>
                <a:spcPct val="220000"/>
              </a:lnSpc>
              <a:buNone/>
            </a:pPr>
            <a:r>
              <a:rPr lang="en-HK" sz="2400" dirty="0"/>
              <a:t>Acti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A1B6B49-3256-913B-52B7-FDB8659E4D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13811" y="1927215"/>
            <a:ext cx="2925935" cy="67739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B42B54E-F259-5ABA-2BB9-AA1CFC54410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9569"/>
          <a:stretch/>
        </p:blipFill>
        <p:spPr>
          <a:xfrm>
            <a:off x="8621034" y="3587929"/>
            <a:ext cx="3490971" cy="198042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17FA237-07BE-FE2B-A07F-409A7EBAB3F2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4957" t="9438" r="14025"/>
          <a:stretch/>
        </p:blipFill>
        <p:spPr>
          <a:xfrm>
            <a:off x="8621034" y="2639744"/>
            <a:ext cx="3031792" cy="84991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EF7F25E-D9B3-FD61-7865-567CF0B035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32968" y="5371891"/>
            <a:ext cx="2937708" cy="711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5434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313AA-0D02-8F68-E4EB-B67EA6C2EE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HK" dirty="0"/>
              <a:t>Figure 3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1DEFCF3-100F-0F08-5491-671F0DE41F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56" t="63591" r="37564" b="9972"/>
          <a:stretch/>
        </p:blipFill>
        <p:spPr>
          <a:xfrm rot="10800000">
            <a:off x="4741296" y="1529324"/>
            <a:ext cx="6446542" cy="380756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C17C7BE-2B7F-6775-3DD0-C968066FFF90}"/>
              </a:ext>
            </a:extLst>
          </p:cNvPr>
          <p:cNvSpPr txBox="1"/>
          <p:nvPr/>
        </p:nvSpPr>
        <p:spPr>
          <a:xfrm>
            <a:off x="4924176" y="5175522"/>
            <a:ext cx="48464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Repeats of 3 western blot</a:t>
            </a:r>
          </a:p>
          <a:p>
            <a:r>
              <a:rPr lang="en-HK" dirty="0"/>
              <a:t>Last two columns were used in the manuscript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C398F16-913A-6EE1-471C-4DCA7E645EC6}"/>
              </a:ext>
            </a:extLst>
          </p:cNvPr>
          <p:cNvCxnSpPr/>
          <p:nvPr/>
        </p:nvCxnSpPr>
        <p:spPr>
          <a:xfrm>
            <a:off x="2326523" y="3764280"/>
            <a:ext cx="19569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920A8E9-71A3-ADD8-323A-2850F484345E}"/>
              </a:ext>
            </a:extLst>
          </p:cNvPr>
          <p:cNvCxnSpPr/>
          <p:nvPr/>
        </p:nvCxnSpPr>
        <p:spPr>
          <a:xfrm>
            <a:off x="2326523" y="4084320"/>
            <a:ext cx="19569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3" name="Picture 12" descr="A close-up of a test&#10;&#10;Description automatically generated">
            <a:extLst>
              <a:ext uri="{FF2B5EF4-FFF2-40B4-BE49-F238E27FC236}">
                <a16:creationId xmlns:a16="http://schemas.microsoft.com/office/drawing/2014/main" id="{94A424DE-AE60-4A70-C3B7-75DBA9CE51C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148" y="2106158"/>
            <a:ext cx="2270957" cy="230143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4779558-84CE-3C18-FB45-7DCD21BBE6DD}"/>
              </a:ext>
            </a:extLst>
          </p:cNvPr>
          <p:cNvSpPr txBox="1"/>
          <p:nvPr/>
        </p:nvSpPr>
        <p:spPr>
          <a:xfrm>
            <a:off x="4907258" y="1321356"/>
            <a:ext cx="2947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b="1" dirty="0">
                <a:solidFill>
                  <a:srgbClr val="FF0000"/>
                </a:solidFill>
              </a:rPr>
              <a:t>Original western blot films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6003464-3C08-A111-B3EB-648F642401BA}"/>
              </a:ext>
            </a:extLst>
          </p:cNvPr>
          <p:cNvCxnSpPr/>
          <p:nvPr/>
        </p:nvCxnSpPr>
        <p:spPr>
          <a:xfrm>
            <a:off x="4005656" y="0"/>
            <a:ext cx="69195" cy="683432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Oval 3">
            <a:extLst>
              <a:ext uri="{FF2B5EF4-FFF2-40B4-BE49-F238E27FC236}">
                <a16:creationId xmlns:a16="http://schemas.microsoft.com/office/drawing/2014/main" id="{704CA88A-0EDB-903B-50D0-B20CEDD21A89}"/>
              </a:ext>
            </a:extLst>
          </p:cNvPr>
          <p:cNvSpPr/>
          <p:nvPr/>
        </p:nvSpPr>
        <p:spPr>
          <a:xfrm>
            <a:off x="6922309" y="3351912"/>
            <a:ext cx="1156687" cy="14648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95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29F56-7DC7-BE16-BE26-0DD01D0CA3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HK" dirty="0"/>
              <a:t>Figure 4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86536C8-81B5-3850-B59C-487B5F8E010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4183"/>
          <a:stretch/>
        </p:blipFill>
        <p:spPr>
          <a:xfrm>
            <a:off x="7832436" y="1084374"/>
            <a:ext cx="3383573" cy="119750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C5BAC74-FB15-F358-7DCC-147DF84B6B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967" t="61644" r="40272" b="33217"/>
          <a:stretch/>
        </p:blipFill>
        <p:spPr>
          <a:xfrm>
            <a:off x="8281562" y="2498159"/>
            <a:ext cx="2934447" cy="50708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AAEB4BC-6BFF-F09E-4717-EB7562475AC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18" t="50947" r="38749" b="42400"/>
          <a:stretch/>
        </p:blipFill>
        <p:spPr>
          <a:xfrm rot="10800000">
            <a:off x="7241787" y="3026756"/>
            <a:ext cx="3195738" cy="51498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DA0C1C9-B0AC-B55C-5DD9-26C03C705D4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-33636"/>
          <a:stretch/>
        </p:blipFill>
        <p:spPr>
          <a:xfrm>
            <a:off x="8215110" y="3541744"/>
            <a:ext cx="2601547" cy="870458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2FE367BA-8114-C726-B1D9-9084967AAD04}"/>
              </a:ext>
            </a:extLst>
          </p:cNvPr>
          <p:cNvSpPr txBox="1"/>
          <p:nvPr/>
        </p:nvSpPr>
        <p:spPr>
          <a:xfrm>
            <a:off x="8342239" y="931257"/>
            <a:ext cx="21403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 Narrow" panose="020B0606020202030204" pitchFamily="34" charset="0"/>
              </a:rPr>
              <a:t>Veh  </a:t>
            </a:r>
            <a:r>
              <a:rPr lang="en-US" sz="900" dirty="0" err="1">
                <a:latin typeface="Arial Narrow" panose="020B0606020202030204" pitchFamily="34" charset="0"/>
              </a:rPr>
              <a:t>EHop</a:t>
            </a:r>
            <a:r>
              <a:rPr lang="en-US" sz="900" dirty="0">
                <a:latin typeface="Arial Narrow" panose="020B0606020202030204" pitchFamily="34" charset="0"/>
              </a:rPr>
              <a:t> Veh  </a:t>
            </a:r>
            <a:r>
              <a:rPr lang="en-US" sz="900" dirty="0" err="1">
                <a:latin typeface="Arial Narrow" panose="020B0606020202030204" pitchFamily="34" charset="0"/>
              </a:rPr>
              <a:t>EHop</a:t>
            </a:r>
            <a:r>
              <a:rPr lang="en-US" sz="900" dirty="0">
                <a:latin typeface="Arial Narrow" panose="020B0606020202030204" pitchFamily="34" charset="0"/>
              </a:rPr>
              <a:t> </a:t>
            </a:r>
            <a:r>
              <a:rPr lang="en-HK" sz="900" dirty="0">
                <a:latin typeface="Arial Narrow" panose="020B0606020202030204" pitchFamily="34" charset="0"/>
              </a:rPr>
              <a:t> </a:t>
            </a:r>
            <a:r>
              <a:rPr lang="en-US" sz="900" dirty="0">
                <a:latin typeface="Arial Narrow" panose="020B0606020202030204" pitchFamily="34" charset="0"/>
              </a:rPr>
              <a:t>Veh  </a:t>
            </a:r>
            <a:r>
              <a:rPr lang="en-US" sz="900" dirty="0" err="1">
                <a:latin typeface="Arial Narrow" panose="020B0606020202030204" pitchFamily="34" charset="0"/>
              </a:rPr>
              <a:t>EHop</a:t>
            </a:r>
            <a:r>
              <a:rPr lang="en-US" sz="900" dirty="0">
                <a:latin typeface="Arial Narrow" panose="020B0606020202030204" pitchFamily="34" charset="0"/>
              </a:rPr>
              <a:t>  Veh  </a:t>
            </a:r>
            <a:r>
              <a:rPr lang="en-US" sz="900" dirty="0" err="1">
                <a:latin typeface="Arial Narrow" panose="020B0606020202030204" pitchFamily="34" charset="0"/>
              </a:rPr>
              <a:t>EHop</a:t>
            </a:r>
            <a:endParaRPr lang="en-HK" sz="900" dirty="0">
              <a:latin typeface="Arial Narrow" panose="020B060602020203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985072-FD34-6471-1612-50C2C0FE7268}"/>
              </a:ext>
            </a:extLst>
          </p:cNvPr>
          <p:cNvSpPr txBox="1"/>
          <p:nvPr/>
        </p:nvSpPr>
        <p:spPr>
          <a:xfrm>
            <a:off x="8365099" y="759955"/>
            <a:ext cx="597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EGFP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EE22CC7-2307-AA6B-DB4D-D1B347DC8DBB}"/>
              </a:ext>
            </a:extLst>
          </p:cNvPr>
          <p:cNvSpPr txBox="1"/>
          <p:nvPr/>
        </p:nvSpPr>
        <p:spPr>
          <a:xfrm>
            <a:off x="8847059" y="759955"/>
            <a:ext cx="591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  WT  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CC42143-9315-1FF1-073E-505980B9C89F}"/>
              </a:ext>
            </a:extLst>
          </p:cNvPr>
          <p:cNvSpPr txBox="1"/>
          <p:nvPr/>
        </p:nvSpPr>
        <p:spPr>
          <a:xfrm>
            <a:off x="9320093" y="759955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 P29S 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323E086-7665-3E88-3A05-62A289705819}"/>
              </a:ext>
            </a:extLst>
          </p:cNvPr>
          <p:cNvSpPr txBox="1"/>
          <p:nvPr/>
        </p:nvSpPr>
        <p:spPr>
          <a:xfrm>
            <a:off x="9806338" y="759955"/>
            <a:ext cx="709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 A159V 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2333B2C-DB88-3A56-1124-FD4019954704}"/>
              </a:ext>
            </a:extLst>
          </p:cNvPr>
          <p:cNvSpPr txBox="1"/>
          <p:nvPr/>
        </p:nvSpPr>
        <p:spPr>
          <a:xfrm>
            <a:off x="6597279" y="1944696"/>
            <a:ext cx="927113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ctin</a:t>
            </a:r>
          </a:p>
          <a:p>
            <a:endParaRPr lang="en-HK" dirty="0"/>
          </a:p>
          <a:p>
            <a:r>
              <a:rPr lang="en-HK" dirty="0"/>
              <a:t>PIK3CA</a:t>
            </a:r>
          </a:p>
          <a:p>
            <a:endParaRPr lang="en-HK" dirty="0"/>
          </a:p>
          <a:p>
            <a:r>
              <a:rPr lang="en-HK" dirty="0"/>
              <a:t>t-S6</a:t>
            </a:r>
          </a:p>
          <a:p>
            <a:endParaRPr lang="en-HK" dirty="0"/>
          </a:p>
          <a:p>
            <a:endParaRPr lang="en-HK" dirty="0"/>
          </a:p>
          <a:p>
            <a:r>
              <a:rPr lang="en-HK" dirty="0"/>
              <a:t>p-S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3552268-E475-5F51-0D08-F4798A77B6BE}"/>
              </a:ext>
            </a:extLst>
          </p:cNvPr>
          <p:cNvSpPr txBox="1"/>
          <p:nvPr/>
        </p:nvSpPr>
        <p:spPr>
          <a:xfrm>
            <a:off x="5267380" y="97945"/>
            <a:ext cx="2947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b="1" dirty="0">
                <a:solidFill>
                  <a:srgbClr val="FF0000"/>
                </a:solidFill>
              </a:rPr>
              <a:t>Original western blot films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746284E-1C8B-569B-E263-27F140D24AF1}"/>
              </a:ext>
            </a:extLst>
          </p:cNvPr>
          <p:cNvCxnSpPr/>
          <p:nvPr/>
        </p:nvCxnSpPr>
        <p:spPr>
          <a:xfrm>
            <a:off x="5232782" y="67698"/>
            <a:ext cx="69195" cy="683432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7" name="Picture 56">
            <a:extLst>
              <a:ext uri="{FF2B5EF4-FFF2-40B4-BE49-F238E27FC236}">
                <a16:creationId xmlns:a16="http://schemas.microsoft.com/office/drawing/2014/main" id="{D30AF5BC-0143-284A-B91A-24AA5C29E84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2068" t="53295" r="45648" b="44668"/>
          <a:stretch/>
        </p:blipFill>
        <p:spPr>
          <a:xfrm>
            <a:off x="1684727" y="2884345"/>
            <a:ext cx="493200" cy="247488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7F21799B-C3B0-F823-0ED4-2A944725F97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4273" t="53432" r="43598" b="44669"/>
          <a:stretch/>
        </p:blipFill>
        <p:spPr>
          <a:xfrm>
            <a:off x="2186810" y="2884345"/>
            <a:ext cx="493200" cy="247488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4B273C0C-F611-EF14-0EE9-806F6AC21BA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6363" t="53538" r="41508" b="44563"/>
          <a:stretch/>
        </p:blipFill>
        <p:spPr>
          <a:xfrm>
            <a:off x="2690015" y="2884343"/>
            <a:ext cx="493200" cy="247489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232B2390-2714-F31B-1C1F-873DF224D36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8453" t="53538" r="39418" b="44563"/>
          <a:stretch/>
        </p:blipFill>
        <p:spPr>
          <a:xfrm>
            <a:off x="3198100" y="2884343"/>
            <a:ext cx="493200" cy="24749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FAD00DF8-7BE1-E014-9075-0E79EF598F5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763" t="63574" r="43795" b="34388"/>
          <a:stretch/>
        </p:blipFill>
        <p:spPr>
          <a:xfrm>
            <a:off x="3198100" y="2359246"/>
            <a:ext cx="493200" cy="231579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C240E058-D36C-F2AD-0835-93E397AD23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627" t="63487" r="51561" b="34166"/>
          <a:stretch/>
        </p:blipFill>
        <p:spPr>
          <a:xfrm>
            <a:off x="1684727" y="2359246"/>
            <a:ext cx="493200" cy="231579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9482C241-3348-E12E-3D86-167DA757BD8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36" t="63702" r="49049" b="34283"/>
          <a:stretch/>
        </p:blipFill>
        <p:spPr>
          <a:xfrm>
            <a:off x="2186810" y="2359246"/>
            <a:ext cx="493200" cy="231579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CF830E88-74EC-9A40-4C70-DF29218E04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918" t="63560" r="46375" b="34180"/>
          <a:stretch/>
        </p:blipFill>
        <p:spPr>
          <a:xfrm>
            <a:off x="2690015" y="2359246"/>
            <a:ext cx="493200" cy="231579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F9D9DB63-27B5-7EEB-154B-EE36989A5C7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3" t="9658" r="71893" b="87982"/>
          <a:stretch/>
        </p:blipFill>
        <p:spPr>
          <a:xfrm>
            <a:off x="1684727" y="3141050"/>
            <a:ext cx="493200" cy="210975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175A80D2-2393-8D09-1E01-31B8622AD37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54" t="9706" r="57351" b="87933"/>
          <a:stretch/>
        </p:blipFill>
        <p:spPr>
          <a:xfrm>
            <a:off x="2690015" y="3141050"/>
            <a:ext cx="493200" cy="210975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1052E453-C6F5-B9AB-0920-75B152EC4D2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45" t="9474" r="50080" b="88265"/>
          <a:stretch/>
        </p:blipFill>
        <p:spPr>
          <a:xfrm>
            <a:off x="3198100" y="3141050"/>
            <a:ext cx="493200" cy="210975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6F4E7D2A-FD10-B2BB-0E38-1D3A06CE10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64" t="9933" r="65085" b="87907"/>
          <a:stretch/>
        </p:blipFill>
        <p:spPr>
          <a:xfrm>
            <a:off x="2186810" y="3141050"/>
            <a:ext cx="493200" cy="210975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BEB37B11-84A5-2AD2-71FC-549BBC6A793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9920" t="6638" r="47659"/>
          <a:stretch/>
        </p:blipFill>
        <p:spPr>
          <a:xfrm>
            <a:off x="2186810" y="2609202"/>
            <a:ext cx="493200" cy="265454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7B4746C9-0669-02F5-64B1-83B826E168F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510" t="6638" r="71069"/>
          <a:stretch/>
        </p:blipFill>
        <p:spPr>
          <a:xfrm>
            <a:off x="1684727" y="2609202"/>
            <a:ext cx="493200" cy="265454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C0027BD4-021D-EC7A-5FCD-359DC51EE32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2769" t="7019" r="24810" b="-381"/>
          <a:stretch/>
        </p:blipFill>
        <p:spPr>
          <a:xfrm>
            <a:off x="2690015" y="2609202"/>
            <a:ext cx="493200" cy="265454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8613B044-AA5C-87EE-361F-73A9BAF938C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7219" t="6638" r="360"/>
          <a:stretch/>
        </p:blipFill>
        <p:spPr>
          <a:xfrm>
            <a:off x="3198100" y="2609202"/>
            <a:ext cx="493200" cy="265454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C2FFF912-1289-AA90-A28D-77FE0797D23C}"/>
              </a:ext>
            </a:extLst>
          </p:cNvPr>
          <p:cNvSpPr txBox="1"/>
          <p:nvPr/>
        </p:nvSpPr>
        <p:spPr>
          <a:xfrm>
            <a:off x="1013714" y="2306378"/>
            <a:ext cx="723275" cy="1141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25000"/>
              </a:lnSpc>
            </a:pPr>
            <a:r>
              <a:rPr lang="en-US" sz="1400" b="1" dirty="0">
                <a:latin typeface="Arial Narrow" panose="020B0606020202030204" pitchFamily="34" charset="0"/>
                <a:cs typeface="Arial" panose="020B0604020202020204" pitchFamily="34" charset="0"/>
              </a:rPr>
              <a:t>PIK3CA</a:t>
            </a:r>
          </a:p>
          <a:p>
            <a:pPr algn="r">
              <a:lnSpc>
                <a:spcPct val="125000"/>
              </a:lnSpc>
            </a:pPr>
            <a:r>
              <a:rPr lang="en-US" sz="1400" b="1" dirty="0">
                <a:latin typeface="Arial Narrow" panose="020B0606020202030204" pitchFamily="34" charset="0"/>
                <a:cs typeface="Arial" panose="020B0604020202020204" pitchFamily="34" charset="0"/>
              </a:rPr>
              <a:t>t-S6</a:t>
            </a:r>
          </a:p>
          <a:p>
            <a:pPr algn="r">
              <a:lnSpc>
                <a:spcPct val="125000"/>
              </a:lnSpc>
            </a:pPr>
            <a:r>
              <a:rPr lang="en-US" sz="1400" b="1" dirty="0">
                <a:latin typeface="Arial Narrow" panose="020B0606020202030204" pitchFamily="34" charset="0"/>
                <a:cs typeface="Arial" panose="020B0604020202020204" pitchFamily="34" charset="0"/>
              </a:rPr>
              <a:t>p-S6</a:t>
            </a:r>
          </a:p>
          <a:p>
            <a:pPr algn="r">
              <a:lnSpc>
                <a:spcPct val="125000"/>
              </a:lnSpc>
            </a:pPr>
            <a:r>
              <a:rPr lang="en-US" sz="1400" b="1" dirty="0">
                <a:latin typeface="Arial Narrow" panose="020B060602020203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37B64D0-22B3-EB9A-6315-82B197FE64F5}"/>
              </a:ext>
            </a:extLst>
          </p:cNvPr>
          <p:cNvSpPr txBox="1"/>
          <p:nvPr/>
        </p:nvSpPr>
        <p:spPr>
          <a:xfrm>
            <a:off x="1632674" y="2158548"/>
            <a:ext cx="21403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>
                <a:latin typeface="Arial Narrow" panose="020B0606020202030204" pitchFamily="34" charset="0"/>
              </a:rPr>
              <a:t>Veh</a:t>
            </a:r>
            <a:r>
              <a:rPr lang="en-US" sz="900">
                <a:latin typeface="Arial Narrow" panose="020B0606020202030204" pitchFamily="34" charset="0"/>
              </a:rPr>
              <a:t>  </a:t>
            </a:r>
            <a:r>
              <a:rPr lang="en-US" sz="900" err="1">
                <a:latin typeface="Arial Narrow" panose="020B0606020202030204" pitchFamily="34" charset="0"/>
              </a:rPr>
              <a:t>EHop</a:t>
            </a:r>
            <a:r>
              <a:rPr lang="en-US" sz="900">
                <a:latin typeface="Arial Narrow" panose="020B0606020202030204" pitchFamily="34" charset="0"/>
              </a:rPr>
              <a:t> </a:t>
            </a:r>
            <a:r>
              <a:rPr lang="en-US" sz="900" err="1">
                <a:latin typeface="Arial Narrow" panose="020B0606020202030204" pitchFamily="34" charset="0"/>
              </a:rPr>
              <a:t>Veh</a:t>
            </a:r>
            <a:r>
              <a:rPr lang="en-US" sz="900">
                <a:latin typeface="Arial Narrow" panose="020B0606020202030204" pitchFamily="34" charset="0"/>
              </a:rPr>
              <a:t>  </a:t>
            </a:r>
            <a:r>
              <a:rPr lang="en-US" sz="900" err="1">
                <a:latin typeface="Arial Narrow" panose="020B0606020202030204" pitchFamily="34" charset="0"/>
              </a:rPr>
              <a:t>EHop</a:t>
            </a:r>
            <a:r>
              <a:rPr lang="en-US" sz="900">
                <a:latin typeface="Arial Narrow" panose="020B0606020202030204" pitchFamily="34" charset="0"/>
              </a:rPr>
              <a:t> </a:t>
            </a:r>
            <a:r>
              <a:rPr lang="en-HK" sz="900">
                <a:latin typeface="Arial Narrow" panose="020B0606020202030204" pitchFamily="34" charset="0"/>
              </a:rPr>
              <a:t> </a:t>
            </a:r>
            <a:r>
              <a:rPr lang="en-US" sz="900" err="1">
                <a:latin typeface="Arial Narrow" panose="020B0606020202030204" pitchFamily="34" charset="0"/>
              </a:rPr>
              <a:t>Veh</a:t>
            </a:r>
            <a:r>
              <a:rPr lang="en-US" sz="900">
                <a:latin typeface="Arial Narrow" panose="020B0606020202030204" pitchFamily="34" charset="0"/>
              </a:rPr>
              <a:t>  </a:t>
            </a:r>
            <a:r>
              <a:rPr lang="en-US" sz="900" err="1">
                <a:latin typeface="Arial Narrow" panose="020B0606020202030204" pitchFamily="34" charset="0"/>
              </a:rPr>
              <a:t>EHop</a:t>
            </a:r>
            <a:r>
              <a:rPr lang="en-US" sz="900">
                <a:latin typeface="Arial Narrow" panose="020B0606020202030204" pitchFamily="34" charset="0"/>
              </a:rPr>
              <a:t>  </a:t>
            </a:r>
            <a:r>
              <a:rPr lang="en-US" sz="900" err="1">
                <a:latin typeface="Arial Narrow" panose="020B0606020202030204" pitchFamily="34" charset="0"/>
              </a:rPr>
              <a:t>Veh</a:t>
            </a:r>
            <a:r>
              <a:rPr lang="en-US" sz="900">
                <a:latin typeface="Arial Narrow" panose="020B0606020202030204" pitchFamily="34" charset="0"/>
              </a:rPr>
              <a:t>  </a:t>
            </a:r>
            <a:r>
              <a:rPr lang="en-US" sz="900" err="1">
                <a:latin typeface="Arial Narrow" panose="020B0606020202030204" pitchFamily="34" charset="0"/>
              </a:rPr>
              <a:t>EHop</a:t>
            </a:r>
            <a:endParaRPr lang="en-HK" sz="900">
              <a:latin typeface="Arial Narrow" panose="020B060602020203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D08BEF2-4559-D706-996B-A9AE2E88AADB}"/>
              </a:ext>
            </a:extLst>
          </p:cNvPr>
          <p:cNvSpPr txBox="1"/>
          <p:nvPr/>
        </p:nvSpPr>
        <p:spPr>
          <a:xfrm>
            <a:off x="1655534" y="1987246"/>
            <a:ext cx="597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EGFP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E9561F6-C0FC-D470-92E6-28C472AAF337}"/>
              </a:ext>
            </a:extLst>
          </p:cNvPr>
          <p:cNvSpPr txBox="1"/>
          <p:nvPr/>
        </p:nvSpPr>
        <p:spPr>
          <a:xfrm>
            <a:off x="2137494" y="1987246"/>
            <a:ext cx="591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  WT  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81ECB25-4CB3-5576-BD2F-77E48D126A61}"/>
              </a:ext>
            </a:extLst>
          </p:cNvPr>
          <p:cNvSpPr txBox="1"/>
          <p:nvPr/>
        </p:nvSpPr>
        <p:spPr>
          <a:xfrm>
            <a:off x="2610528" y="1987246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 P29S 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3D116F9-A5E4-202F-35E9-F40A99184671}"/>
              </a:ext>
            </a:extLst>
          </p:cNvPr>
          <p:cNvSpPr txBox="1"/>
          <p:nvPr/>
        </p:nvSpPr>
        <p:spPr>
          <a:xfrm>
            <a:off x="3096773" y="1987246"/>
            <a:ext cx="709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u="sng">
                <a:latin typeface="Arial Narrow" panose="020B0606020202030204" pitchFamily="34" charset="0"/>
              </a:rPr>
              <a:t>  A159V  </a:t>
            </a:r>
            <a:endParaRPr lang="en-HK" sz="1200" b="1" u="sng">
              <a:latin typeface="Arial Narrow" panose="020B060602020203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0F6662F-DECB-086C-6B62-4BEF3DDA0BB1}"/>
              </a:ext>
            </a:extLst>
          </p:cNvPr>
          <p:cNvSpPr txBox="1"/>
          <p:nvPr/>
        </p:nvSpPr>
        <p:spPr>
          <a:xfrm>
            <a:off x="1709506" y="2469349"/>
            <a:ext cx="20345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 Narrow" panose="020B0606020202030204" pitchFamily="34" charset="0"/>
              </a:rPr>
              <a:t>1      2.05     1       0.07       1     0.77      1      0.34</a:t>
            </a:r>
            <a:endParaRPr lang="en-HK" sz="800">
              <a:latin typeface="Arial Narrow" panose="020B060602020203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80E537C-78C8-7FB9-42BC-523EC0891166}"/>
              </a:ext>
            </a:extLst>
          </p:cNvPr>
          <p:cNvSpPr txBox="1"/>
          <p:nvPr/>
        </p:nvSpPr>
        <p:spPr>
          <a:xfrm>
            <a:off x="1700805" y="2984872"/>
            <a:ext cx="20345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 Narrow" panose="020B0606020202030204" pitchFamily="34" charset="0"/>
              </a:rPr>
              <a:t>1      1.76     1       0.11       1     0.76      1      0.16</a:t>
            </a:r>
            <a:endParaRPr lang="en-HK" sz="800">
              <a:latin typeface="Arial Narrow" panose="020B060602020203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03372DA-83F2-69D8-2873-E03E80F800C8}"/>
              </a:ext>
            </a:extLst>
          </p:cNvPr>
          <p:cNvSpPr txBox="1"/>
          <p:nvPr/>
        </p:nvSpPr>
        <p:spPr>
          <a:xfrm>
            <a:off x="1701906" y="3294895"/>
            <a:ext cx="20345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 Narrow" panose="020B0606020202030204" pitchFamily="34" charset="0"/>
              </a:rPr>
              <a:t>1      1.36     1       0.62       1     0.95      1      0.82</a:t>
            </a:r>
            <a:endParaRPr lang="en-HK" sz="800">
              <a:latin typeface="Arial Narrow" panose="020B060602020203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74C1CB7-91DA-251F-50EE-361F3EB71C0C}"/>
              </a:ext>
            </a:extLst>
          </p:cNvPr>
          <p:cNvSpPr txBox="1"/>
          <p:nvPr/>
        </p:nvSpPr>
        <p:spPr>
          <a:xfrm>
            <a:off x="1700804" y="2737274"/>
            <a:ext cx="20345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 Narrow" panose="020B0606020202030204" pitchFamily="34" charset="0"/>
              </a:rPr>
              <a:t>1      2.80     1       1.34       1     0.91      1      0.24</a:t>
            </a:r>
            <a:endParaRPr lang="en-HK" sz="80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39917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18939-FBEA-CBE7-CED1-9F1C5E04B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HK" dirty="0"/>
              <a:t>Supplementary Fig.2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C1D2FDE-1F99-085E-2AA7-7670282061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5616" y="2536912"/>
            <a:ext cx="4066384" cy="186553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D2249C9-74A0-A89E-1A47-3C93098756B0}"/>
              </a:ext>
            </a:extLst>
          </p:cNvPr>
          <p:cNvSpPr txBox="1"/>
          <p:nvPr/>
        </p:nvSpPr>
        <p:spPr>
          <a:xfrm>
            <a:off x="6379226" y="2648124"/>
            <a:ext cx="1699311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HK" dirty="0"/>
              <a:t>PAK1</a:t>
            </a:r>
          </a:p>
          <a:p>
            <a:pPr algn="r"/>
            <a:r>
              <a:rPr lang="en-HK" dirty="0"/>
              <a:t>(high exposure)</a:t>
            </a:r>
          </a:p>
          <a:p>
            <a:pPr algn="r"/>
            <a:endParaRPr lang="en-HK" dirty="0"/>
          </a:p>
          <a:p>
            <a:pPr algn="r"/>
            <a:r>
              <a:rPr lang="en-HK" dirty="0"/>
              <a:t>PAK1</a:t>
            </a:r>
          </a:p>
          <a:p>
            <a:pPr algn="r"/>
            <a:r>
              <a:rPr lang="en-HK" dirty="0"/>
              <a:t>(low exposure)</a:t>
            </a:r>
          </a:p>
          <a:p>
            <a:pPr algn="r"/>
            <a:endParaRPr lang="en-HK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3905D3B-C566-0631-D2C5-CE916CC16AA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3447" b="9809"/>
          <a:stretch/>
        </p:blipFill>
        <p:spPr>
          <a:xfrm>
            <a:off x="8125616" y="4430395"/>
            <a:ext cx="3462828" cy="206248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192ECAA-CB19-C81E-30DD-113DE5F92813}"/>
              </a:ext>
            </a:extLst>
          </p:cNvPr>
          <p:cNvSpPr txBox="1"/>
          <p:nvPr/>
        </p:nvSpPr>
        <p:spPr>
          <a:xfrm>
            <a:off x="7072567" y="4722971"/>
            <a:ext cx="69923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ctin</a:t>
            </a:r>
          </a:p>
          <a:p>
            <a:endParaRPr lang="en-HK" dirty="0"/>
          </a:p>
          <a:p>
            <a:endParaRPr lang="en-HK" dirty="0"/>
          </a:p>
          <a:p>
            <a:endParaRPr lang="en-HK" dirty="0"/>
          </a:p>
          <a:p>
            <a:r>
              <a:rPr lang="en-HK" dirty="0"/>
              <a:t>Rac1</a:t>
            </a:r>
          </a:p>
          <a:p>
            <a:endParaRPr lang="en-HK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08B6FFE-D780-7151-CC35-C3FE85983B61}"/>
              </a:ext>
            </a:extLst>
          </p:cNvPr>
          <p:cNvSpPr txBox="1"/>
          <p:nvPr/>
        </p:nvSpPr>
        <p:spPr>
          <a:xfrm rot="16200000">
            <a:off x="9259822" y="1007778"/>
            <a:ext cx="849913" cy="25869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HK" dirty="0"/>
              <a:t>EGFP</a:t>
            </a:r>
          </a:p>
          <a:p>
            <a:pPr>
              <a:lnSpc>
                <a:spcPct val="130000"/>
              </a:lnSpc>
            </a:pPr>
            <a:r>
              <a:rPr lang="en-HK" dirty="0"/>
              <a:t>WT</a:t>
            </a:r>
          </a:p>
          <a:p>
            <a:pPr>
              <a:lnSpc>
                <a:spcPct val="130000"/>
              </a:lnSpc>
            </a:pPr>
            <a:r>
              <a:rPr lang="en-HK" dirty="0"/>
              <a:t>P29S</a:t>
            </a:r>
          </a:p>
          <a:p>
            <a:pPr>
              <a:lnSpc>
                <a:spcPct val="130000"/>
              </a:lnSpc>
            </a:pPr>
            <a:r>
              <a:rPr lang="en-HK" dirty="0"/>
              <a:t>K116N</a:t>
            </a:r>
          </a:p>
          <a:p>
            <a:pPr>
              <a:lnSpc>
                <a:spcPct val="130000"/>
              </a:lnSpc>
            </a:pPr>
            <a:r>
              <a:rPr lang="en-HK" dirty="0"/>
              <a:t>A159V</a:t>
            </a:r>
          </a:p>
          <a:p>
            <a:pPr>
              <a:lnSpc>
                <a:spcPct val="130000"/>
              </a:lnSpc>
            </a:pPr>
            <a:r>
              <a:rPr lang="en-HK" dirty="0"/>
              <a:t>G15S</a:t>
            </a:r>
          </a:p>
          <a:p>
            <a:pPr>
              <a:lnSpc>
                <a:spcPct val="130000"/>
              </a:lnSpc>
            </a:pPr>
            <a:r>
              <a:rPr lang="en-HK" dirty="0"/>
              <a:t>N39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D25BDA-C4FB-D8FA-EF7E-EEE98E306850}"/>
              </a:ext>
            </a:extLst>
          </p:cNvPr>
          <p:cNvSpPr txBox="1"/>
          <p:nvPr/>
        </p:nvSpPr>
        <p:spPr>
          <a:xfrm>
            <a:off x="5084416" y="1524599"/>
            <a:ext cx="2947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b="1" dirty="0">
                <a:solidFill>
                  <a:srgbClr val="FF0000"/>
                </a:solidFill>
              </a:rPr>
              <a:t>Original western blot film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0EC9DF7-07C8-30FB-729E-0CC15BC9E0B1}"/>
              </a:ext>
            </a:extLst>
          </p:cNvPr>
          <p:cNvSpPr txBox="1"/>
          <p:nvPr/>
        </p:nvSpPr>
        <p:spPr>
          <a:xfrm>
            <a:off x="8196767" y="1662965"/>
            <a:ext cx="3031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u="sng" dirty="0"/>
              <a:t>       PECAPJ41CLONED2           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22E9954-49C1-DE38-FC14-681B893E6BA8}"/>
              </a:ext>
            </a:extLst>
          </p:cNvPr>
          <p:cNvCxnSpPr/>
          <p:nvPr/>
        </p:nvCxnSpPr>
        <p:spPr>
          <a:xfrm>
            <a:off x="11228559" y="3086491"/>
            <a:ext cx="19569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E9CA1B5-6448-4E09-CD75-1A631CE35A99}"/>
              </a:ext>
            </a:extLst>
          </p:cNvPr>
          <p:cNvCxnSpPr/>
          <p:nvPr/>
        </p:nvCxnSpPr>
        <p:spPr>
          <a:xfrm>
            <a:off x="8125616" y="4031371"/>
            <a:ext cx="19569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797C525-9E30-A8A2-7587-A5F4538ABB9F}"/>
              </a:ext>
            </a:extLst>
          </p:cNvPr>
          <p:cNvCxnSpPr/>
          <p:nvPr/>
        </p:nvCxnSpPr>
        <p:spPr>
          <a:xfrm>
            <a:off x="11380959" y="3238891"/>
            <a:ext cx="19569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3" name="Picture 22" descr="A close-up of a test results&#10;&#10;Description automatically generated">
            <a:extLst>
              <a:ext uri="{FF2B5EF4-FFF2-40B4-BE49-F238E27FC236}">
                <a16:creationId xmlns:a16="http://schemas.microsoft.com/office/drawing/2014/main" id="{A3C58421-48F3-AF45-1707-4C790D50FA7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174" y="2418769"/>
            <a:ext cx="4976291" cy="2545301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A0798B8-7F3C-A556-D0D0-096D70908DAD}"/>
              </a:ext>
            </a:extLst>
          </p:cNvPr>
          <p:cNvCxnSpPr/>
          <p:nvPr/>
        </p:nvCxnSpPr>
        <p:spPr>
          <a:xfrm>
            <a:off x="5015221" y="-178274"/>
            <a:ext cx="69195" cy="683432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347794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9440E-3148-D52A-A646-906BD92755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06667"/>
            <a:ext cx="10515600" cy="1325563"/>
          </a:xfrm>
        </p:spPr>
        <p:txBody>
          <a:bodyPr/>
          <a:lstStyle/>
          <a:p>
            <a:r>
              <a:rPr lang="en-HK" dirty="0"/>
              <a:t>Supple-Fig.3C</a:t>
            </a:r>
          </a:p>
        </p:txBody>
      </p:sp>
      <p:pic>
        <p:nvPicPr>
          <p:cNvPr id="5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3754821E-27C9-6ED0-A463-9B7D43F57E4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1" y="1960666"/>
            <a:ext cx="4567294" cy="2634193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9032240-BD48-BEB6-BE7B-50C01BF7AE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982656">
            <a:off x="6265658" y="168324"/>
            <a:ext cx="4972235" cy="652135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02C029D-CE81-C629-4B7B-603A16422D70}"/>
              </a:ext>
            </a:extLst>
          </p:cNvPr>
          <p:cNvSpPr txBox="1"/>
          <p:nvPr/>
        </p:nvSpPr>
        <p:spPr>
          <a:xfrm>
            <a:off x="8299048" y="254643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b="1" dirty="0">
                <a:solidFill>
                  <a:srgbClr val="FF0000"/>
                </a:solidFill>
              </a:rPr>
              <a:t>original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6FB1093-D4BE-275D-0E48-B546845756E1}"/>
              </a:ext>
            </a:extLst>
          </p:cNvPr>
          <p:cNvCxnSpPr/>
          <p:nvPr/>
        </p:nvCxnSpPr>
        <p:spPr>
          <a:xfrm>
            <a:off x="5232782" y="67698"/>
            <a:ext cx="69195" cy="683432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Oval 3">
            <a:extLst>
              <a:ext uri="{FF2B5EF4-FFF2-40B4-BE49-F238E27FC236}">
                <a16:creationId xmlns:a16="http://schemas.microsoft.com/office/drawing/2014/main" id="{4D2B4157-E07D-01EC-DFF4-776498BD39F4}"/>
              </a:ext>
            </a:extLst>
          </p:cNvPr>
          <p:cNvSpPr/>
          <p:nvPr/>
        </p:nvSpPr>
        <p:spPr>
          <a:xfrm>
            <a:off x="8386814" y="4899659"/>
            <a:ext cx="520965" cy="1066801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79501E-6956-7423-3CDB-A06C74C3D180}"/>
              </a:ext>
            </a:extLst>
          </p:cNvPr>
          <p:cNvSpPr txBox="1"/>
          <p:nvPr/>
        </p:nvSpPr>
        <p:spPr>
          <a:xfrm>
            <a:off x="6711337" y="2511983"/>
            <a:ext cx="1157689" cy="35132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HK" dirty="0"/>
              <a:t>p-MAPK1</a:t>
            </a:r>
          </a:p>
          <a:p>
            <a:pPr>
              <a:lnSpc>
                <a:spcPct val="95000"/>
              </a:lnSpc>
            </a:pPr>
            <a:endParaRPr lang="en-HK" dirty="0"/>
          </a:p>
          <a:p>
            <a:pPr>
              <a:lnSpc>
                <a:spcPct val="95000"/>
              </a:lnSpc>
            </a:pPr>
            <a:r>
              <a:rPr lang="en-HK" dirty="0"/>
              <a:t>p-P70S6K</a:t>
            </a:r>
          </a:p>
          <a:p>
            <a:pPr>
              <a:lnSpc>
                <a:spcPct val="95000"/>
              </a:lnSpc>
            </a:pPr>
            <a:endParaRPr lang="en-HK" dirty="0"/>
          </a:p>
          <a:p>
            <a:pPr>
              <a:lnSpc>
                <a:spcPct val="95000"/>
              </a:lnSpc>
            </a:pPr>
            <a:r>
              <a:rPr lang="en-HK" dirty="0"/>
              <a:t>t-S6</a:t>
            </a:r>
          </a:p>
          <a:p>
            <a:pPr>
              <a:lnSpc>
                <a:spcPct val="95000"/>
              </a:lnSpc>
            </a:pPr>
            <a:endParaRPr lang="en-HK" dirty="0"/>
          </a:p>
          <a:p>
            <a:pPr>
              <a:lnSpc>
                <a:spcPct val="95000"/>
              </a:lnSpc>
            </a:pPr>
            <a:r>
              <a:rPr lang="en-HK" dirty="0"/>
              <a:t>p-S6</a:t>
            </a:r>
          </a:p>
          <a:p>
            <a:pPr>
              <a:lnSpc>
                <a:spcPct val="95000"/>
              </a:lnSpc>
            </a:pPr>
            <a:endParaRPr lang="en-HK" dirty="0"/>
          </a:p>
          <a:p>
            <a:pPr>
              <a:lnSpc>
                <a:spcPct val="95000"/>
              </a:lnSpc>
            </a:pPr>
            <a:r>
              <a:rPr lang="en-HK" dirty="0"/>
              <a:t>p-Akt</a:t>
            </a:r>
          </a:p>
          <a:p>
            <a:pPr>
              <a:lnSpc>
                <a:spcPct val="95000"/>
              </a:lnSpc>
            </a:pPr>
            <a:endParaRPr lang="en-HK" dirty="0"/>
          </a:p>
          <a:p>
            <a:pPr>
              <a:lnSpc>
                <a:spcPct val="95000"/>
              </a:lnSpc>
            </a:pPr>
            <a:r>
              <a:rPr lang="en-HK" dirty="0"/>
              <a:t>Rac1</a:t>
            </a:r>
          </a:p>
          <a:p>
            <a:pPr>
              <a:lnSpc>
                <a:spcPct val="95000"/>
              </a:lnSpc>
            </a:pPr>
            <a:endParaRPr lang="en-HK" dirty="0"/>
          </a:p>
          <a:p>
            <a:pPr>
              <a:lnSpc>
                <a:spcPct val="95000"/>
              </a:lnSpc>
            </a:pPr>
            <a:r>
              <a:rPr lang="en-HK" dirty="0"/>
              <a:t>Act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B05A04-D4D7-5151-0A66-B604C9D6CC28}"/>
              </a:ext>
            </a:extLst>
          </p:cNvPr>
          <p:cNvSpPr txBox="1"/>
          <p:nvPr/>
        </p:nvSpPr>
        <p:spPr>
          <a:xfrm>
            <a:off x="8387919" y="6433346"/>
            <a:ext cx="886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400" b="1" dirty="0"/>
              <a:t>PDC-T7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9B8365-5CB8-D4FE-5515-7AA26D20490A}"/>
              </a:ext>
            </a:extLst>
          </p:cNvPr>
          <p:cNvSpPr txBox="1"/>
          <p:nvPr/>
        </p:nvSpPr>
        <p:spPr>
          <a:xfrm rot="16200000">
            <a:off x="8569175" y="5913011"/>
            <a:ext cx="617540" cy="6694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HK" sz="900" dirty="0">
                <a:latin typeface="Arial Narrow" panose="020B0606020202030204" pitchFamily="34" charset="0"/>
              </a:rPr>
              <a:t>Ctrl </a:t>
            </a:r>
          </a:p>
          <a:p>
            <a:pPr algn="r"/>
            <a:r>
              <a:rPr lang="en-HK" sz="900" dirty="0">
                <a:latin typeface="Arial Narrow" panose="020B0606020202030204" pitchFamily="34" charset="0"/>
              </a:rPr>
              <a:t>RAC1-WT</a:t>
            </a:r>
          </a:p>
          <a:p>
            <a:pPr algn="r"/>
            <a:r>
              <a:rPr lang="en-HK" sz="900" dirty="0">
                <a:latin typeface="Arial Narrow" panose="020B0606020202030204" pitchFamily="34" charset="0"/>
              </a:rPr>
              <a:t>RAC1-WT</a:t>
            </a:r>
          </a:p>
          <a:p>
            <a:pPr algn="r"/>
            <a:endParaRPr lang="en-HK" sz="1050" dirty="0">
              <a:latin typeface="Arial Narrow" panose="020B060602020203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8BC0071-ECFF-912E-A8FD-410620CA7EED}"/>
              </a:ext>
            </a:extLst>
          </p:cNvPr>
          <p:cNvSpPr txBox="1"/>
          <p:nvPr/>
        </p:nvSpPr>
        <p:spPr>
          <a:xfrm>
            <a:off x="9364064" y="596646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HK" dirty="0"/>
              <a:t>PDX-T76</a:t>
            </a:r>
          </a:p>
        </p:txBody>
      </p:sp>
    </p:spTree>
    <p:extLst>
      <p:ext uri="{BB962C8B-B14F-4D97-AF65-F5344CB8AC3E}">
        <p14:creationId xmlns:p14="http://schemas.microsoft.com/office/powerpoint/2010/main" val="3972022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168</Words>
  <Application>Microsoft Office PowerPoint</Application>
  <PresentationFormat>Widescreen</PresentationFormat>
  <Paragraphs>8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Arial Narrow</vt:lpstr>
      <vt:lpstr>Office Theme</vt:lpstr>
      <vt:lpstr>Figure 2D</vt:lpstr>
      <vt:lpstr>Figure 3C</vt:lpstr>
      <vt:lpstr>Figure 4C</vt:lpstr>
      <vt:lpstr>Supplementary Fig.2C</vt:lpstr>
      <vt:lpstr>Supple-Fig.3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illiam leung</dc:creator>
  <cp:lastModifiedBy>Lui, Wai Yan Vivian</cp:lastModifiedBy>
  <cp:revision>10</cp:revision>
  <dcterms:created xsi:type="dcterms:W3CDTF">2024-11-26T07:25:20Z</dcterms:created>
  <dcterms:modified xsi:type="dcterms:W3CDTF">2024-12-05T15:50:56Z</dcterms:modified>
</cp:coreProperties>
</file>